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2700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A8BA3-8F1D-43E8-AC4A-0168DF746252}" type="datetimeFigureOut">
              <a:rPr lang="en-US" smtClean="0"/>
              <a:pPr/>
              <a:t>2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E8855-4E57-4BC9-812C-BA873484FE0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1930968" y="1382710"/>
            <a:ext cx="1244215" cy="1271800"/>
            <a:chOff x="2083368" y="3440110"/>
            <a:chExt cx="1244215" cy="1271800"/>
          </a:xfrm>
        </p:grpSpPr>
        <p:pic>
          <p:nvPicPr>
            <p:cNvPr id="36" name="Picture 5"/>
            <p:cNvPicPr>
              <a:picLocks noChangeArrowheads="1"/>
            </p:cNvPicPr>
            <p:nvPr/>
          </p:nvPicPr>
          <p:blipFill>
            <a:blip r:embed="rId2">
              <a:biLevel thresh="50000"/>
            </a:blip>
            <a:srcRect l="16652" t="12334" r="17646" b="16091"/>
            <a:stretch>
              <a:fillRect/>
            </a:stretch>
          </p:blipFill>
          <p:spPr bwMode="auto">
            <a:xfrm>
              <a:off x="2251271" y="3618462"/>
              <a:ext cx="940233" cy="9494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" name="TextBox 11"/>
            <p:cNvSpPr txBox="1"/>
            <p:nvPr/>
          </p:nvSpPr>
          <p:spPr>
            <a:xfrm>
              <a:off x="2413638" y="3440110"/>
              <a:ext cx="641522" cy="2205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ontrol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155635" y="4515217"/>
              <a:ext cx="2199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0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1975165" y="3997862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Counts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062554" y="3540662"/>
              <a:ext cx="2904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256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2097824" y="4459072"/>
              <a:ext cx="2199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0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001853" y="4519226"/>
              <a:ext cx="3257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1023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440385" y="4527244"/>
              <a:ext cx="5645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DNA content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266777" y="3624797"/>
              <a:ext cx="907751" cy="9277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3238389" y="1382710"/>
            <a:ext cx="1244215" cy="1267785"/>
            <a:chOff x="3150174" y="3440110"/>
            <a:chExt cx="1244215" cy="1267785"/>
          </a:xfrm>
        </p:grpSpPr>
        <p:pic>
          <p:nvPicPr>
            <p:cNvPr id="1026" name="Picture 2"/>
            <p:cNvPicPr>
              <a:picLocks noChangeArrowheads="1"/>
            </p:cNvPicPr>
            <p:nvPr/>
          </p:nvPicPr>
          <p:blipFill>
            <a:blip r:embed="rId3"/>
            <a:srcRect l="16668" t="12642" r="18465" b="16333"/>
            <a:stretch>
              <a:fillRect/>
            </a:stretch>
          </p:blipFill>
          <p:spPr bwMode="auto">
            <a:xfrm>
              <a:off x="3311914" y="3622832"/>
              <a:ext cx="929789" cy="9407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TextBox 12"/>
            <p:cNvSpPr txBox="1"/>
            <p:nvPr/>
          </p:nvSpPr>
          <p:spPr>
            <a:xfrm>
              <a:off x="3576261" y="3440110"/>
              <a:ext cx="348172" cy="2205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ICI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3041971" y="3993847"/>
              <a:ext cx="4010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Counts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3129360" y="3536647"/>
              <a:ext cx="2904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256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3164630" y="4455057"/>
              <a:ext cx="2199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0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22441" y="4511202"/>
              <a:ext cx="2199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0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68659" y="4515211"/>
              <a:ext cx="3257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1023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507191" y="4523229"/>
              <a:ext cx="5645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 Narrow" pitchFamily="34" charset="0"/>
                </a:rPr>
                <a:t>DNA content</a:t>
              </a:r>
              <a:endParaRPr lang="en-US" sz="600" b="1" dirty="0">
                <a:latin typeface="Arial Narrow" pitchFamily="34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326926" y="3624243"/>
              <a:ext cx="907751" cy="9277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0324" y="2828180"/>
            <a:ext cx="3901350" cy="5908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5" name="TextBox 44"/>
          <p:cNvSpPr txBox="1"/>
          <p:nvPr/>
        </p:nvSpPr>
        <p:spPr>
          <a:xfrm>
            <a:off x="480913" y="2603936"/>
            <a:ext cx="16208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Ratio of G0/G1 to G2/M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171058" y="2603936"/>
            <a:ext cx="7841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.6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±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0.31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517686" y="2603936"/>
            <a:ext cx="7841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1.8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±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0.08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12424" y="7961082"/>
            <a:ext cx="609386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329 100.00  100.00   273.12  41.55     262,209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268   2.59    2.59   134.97  19.37       8,148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6604  63.94   63.94   213.58   8.39     262,209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326  12.84   12.84   318.07   8.34      32,280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1839  17.80   17.80   398.58   5.52      47,401</a:t>
            </a:r>
            <a:endParaRPr lang="en-US" sz="1000" dirty="0">
              <a:latin typeface="Courier" pitchFamily="49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biLevel thresh="50000"/>
          </a:blip>
          <a:srcRect/>
          <a:stretch>
            <a:fillRect/>
          </a:stretch>
        </p:blipFill>
        <p:spPr bwMode="auto">
          <a:xfrm>
            <a:off x="2464090" y="399245"/>
            <a:ext cx="2790825" cy="3190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>
            <a:biLevel thresh="50000"/>
          </a:blip>
          <a:srcRect/>
          <a:stretch>
            <a:fillRect/>
          </a:stretch>
        </p:blipFill>
        <p:spPr bwMode="auto">
          <a:xfrm>
            <a:off x="2408497" y="4874690"/>
            <a:ext cx="2771775" cy="3209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Rectangle 7"/>
          <p:cNvSpPr/>
          <p:nvPr/>
        </p:nvSpPr>
        <p:spPr>
          <a:xfrm>
            <a:off x="172055" y="3500650"/>
            <a:ext cx="633915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359 100.00  100.00   279.34  41.28     216,214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244   2.36    2.36   137.41  20.55       9,174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6465  62.41   62.41   216.75   8.16     216,214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388  13.40   13.40   317.65   8.49      25,352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1989  19.20   19.20   403.42   5.47      51,409</a:t>
            </a:r>
            <a:endParaRPr lang="en-US" sz="1000" dirty="0">
              <a:latin typeface="Courier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8789" y="412124"/>
            <a:ext cx="2411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OH-treated cells -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3031" y="5368344"/>
            <a:ext cx="2411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OH-treated cells -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4472" y="4426772"/>
            <a:ext cx="636098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458 100.00  100.00   267.79  42.40     259,199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259   2.48    2.48   134.88  20.37       8,149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6720  64.26   64.26   207.63   9.13     259,199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436  13.73   13.73   321.88   8.65      30,362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1735  16.59   16.59   392.32   6.06      55,381</a:t>
            </a:r>
            <a:endParaRPr lang="en-US" sz="1000" dirty="0">
              <a:latin typeface="Courier" pitchFamily="49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biLevel thresh="50000"/>
          </a:blip>
          <a:srcRect/>
          <a:stretch>
            <a:fillRect/>
          </a:stretch>
        </p:blipFill>
        <p:spPr bwMode="auto">
          <a:xfrm>
            <a:off x="2048624" y="1205500"/>
            <a:ext cx="27813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biLevel thresh="50000"/>
          </a:blip>
          <a:srcRect/>
          <a:stretch>
            <a:fillRect/>
          </a:stretch>
        </p:blipFill>
        <p:spPr bwMode="auto">
          <a:xfrm>
            <a:off x="1992492" y="5391847"/>
            <a:ext cx="2790825" cy="3190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389133" y="8526160"/>
            <a:ext cx="616577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392 100.00  100.00   293.72  45.56     161,215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791   7.61    7.61   118.59  30.80      13,116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5193  49.97   49.97   217.53   8.55     161,215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232  11.86   11.86   319.87   8.33      24,286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2784  26.79   26.79   409.17   5.91      57,402</a:t>
            </a:r>
            <a:endParaRPr lang="en-US" sz="1000" dirty="0">
              <a:latin typeface="Courier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8789" y="412124"/>
            <a:ext cx="2411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OH-treated cells -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8158" y="5716074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CI-treated cells -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50433" y="3656210"/>
            <a:ext cx="660756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372 100.00  100.00   295.77  44.21     149,213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710   6.85    6.85   117.89  31.29      12,164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5134  49.50   49.50   217.20   8.74     149,213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236  11.92   11.92   320.14   8.45      24,363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2914  28.09   28.09   408.85   5.85      58,409</a:t>
            </a:r>
            <a:endParaRPr lang="en-US" sz="1000" dirty="0">
              <a:latin typeface="Courier" pitchFamily="49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biLevel thresh="50000"/>
          </a:blip>
          <a:srcRect/>
          <a:stretch>
            <a:fillRect/>
          </a:stretch>
        </p:blipFill>
        <p:spPr bwMode="auto">
          <a:xfrm>
            <a:off x="1951395" y="347234"/>
            <a:ext cx="2790825" cy="3190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biLevel thresh="50000"/>
          </a:blip>
          <a:srcRect/>
          <a:stretch>
            <a:fillRect/>
          </a:stretch>
        </p:blipFill>
        <p:spPr bwMode="auto">
          <a:xfrm>
            <a:off x="2033589" y="4647344"/>
            <a:ext cx="2790825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106593" y="7765872"/>
            <a:ext cx="675140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latin typeface="Courier" pitchFamily="49" charset="0"/>
              </a:rPr>
              <a:t>Param</a:t>
            </a:r>
            <a:r>
              <a:rPr lang="en-US" sz="1000" dirty="0" smtClean="0">
                <a:latin typeface="Courier" pitchFamily="49" charset="0"/>
              </a:rPr>
              <a:t> name     M  </a:t>
            </a:r>
            <a:r>
              <a:rPr lang="en-US" sz="1000" dirty="0" err="1" smtClean="0">
                <a:latin typeface="Courier" pitchFamily="49" charset="0"/>
              </a:rPr>
              <a:t>Low,Hig</a:t>
            </a:r>
            <a:r>
              <a:rPr lang="en-US" sz="1000" dirty="0" smtClean="0">
                <a:latin typeface="Courier" pitchFamily="49" charset="0"/>
              </a:rPr>
              <a:t> Events %Total  %Gated   </a:t>
            </a:r>
            <a:r>
              <a:rPr lang="en-US" sz="1000" dirty="0" err="1" smtClean="0">
                <a:latin typeface="Courier" pitchFamily="49" charset="0"/>
              </a:rPr>
              <a:t>GMean</a:t>
            </a:r>
            <a:r>
              <a:rPr lang="en-US" sz="1000" dirty="0" smtClean="0">
                <a:latin typeface="Courier" pitchFamily="49" charset="0"/>
              </a:rPr>
              <a:t>     CV   </a:t>
            </a:r>
            <a:r>
              <a:rPr lang="en-US" sz="1000" dirty="0" err="1" smtClean="0">
                <a:latin typeface="Courier" pitchFamily="49" charset="0"/>
              </a:rPr>
              <a:t>Peak,Value</a:t>
            </a:r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Empt</a:t>
            </a:r>
            <a:r>
              <a:rPr lang="en-US" sz="1000" dirty="0" smtClean="0">
                <a:latin typeface="Courier" pitchFamily="49" charset="0"/>
              </a:rPr>
              <a:t>           0    0,1023  10474 100.00  100.00   304.31  45.32     153,218</a:t>
            </a:r>
          </a:p>
          <a:p>
            <a:r>
              <a:rPr lang="en-US" sz="1000" dirty="0" smtClean="0">
                <a:latin typeface="Courier" pitchFamily="49" charset="0"/>
              </a:rPr>
              <a:t>               1   26, 174    644   6.15    6.15   116.99  30.57      13,148</a:t>
            </a:r>
          </a:p>
          <a:p>
            <a:r>
              <a:rPr lang="en-US" sz="1000" dirty="0" smtClean="0">
                <a:latin typeface="Courier" pitchFamily="49" charset="0"/>
              </a:rPr>
              <a:t>               2  174, 274   5122  48.90   48.90   220.11   8.40     153,218</a:t>
            </a:r>
          </a:p>
          <a:p>
            <a:r>
              <a:rPr lang="en-US" sz="1000" dirty="0" smtClean="0">
                <a:latin typeface="Courier" pitchFamily="49" charset="0"/>
              </a:rPr>
              <a:t>               3  274, 364   1240  11.84   11.84   319.57   8.45      25,340</a:t>
            </a:r>
          </a:p>
          <a:p>
            <a:r>
              <a:rPr lang="en-US" sz="1000" dirty="0" smtClean="0">
                <a:latin typeface="Courier" pitchFamily="49" charset="0"/>
              </a:rPr>
              <a:t>               4  364, 501   3008  28.72   28.72   412.64   5.98      68,410</a:t>
            </a:r>
            <a:endParaRPr lang="en-US" sz="1000" dirty="0">
              <a:latin typeface="Courier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28789" y="412124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CI-treated cells -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9521" y="4917584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CI-treated cells -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441</Words>
  <Application>Microsoft Office PowerPoint</Application>
  <PresentationFormat>A4 Paper (210x297 mm)</PresentationFormat>
  <Paragraphs>5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Courier</vt:lpstr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CUH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mlau</dc:creator>
  <cp:lastModifiedBy>KM Lau</cp:lastModifiedBy>
  <cp:revision>27</cp:revision>
  <dcterms:created xsi:type="dcterms:W3CDTF">2011-01-27T11:26:15Z</dcterms:created>
  <dcterms:modified xsi:type="dcterms:W3CDTF">2019-02-26T08:21:44Z</dcterms:modified>
</cp:coreProperties>
</file>